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4" r:id="rId2"/>
  </p:sldIdLst>
  <p:sldSz cx="9144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4843"/>
    <p:restoredTop sz="94648"/>
  </p:normalViewPr>
  <p:slideViewPr>
    <p:cSldViewPr snapToGrid="0">
      <p:cViewPr varScale="1">
        <p:scale>
          <a:sx n="53" d="100"/>
          <a:sy n="53" d="100"/>
        </p:scale>
        <p:origin x="2120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76CC82-E787-D040-9406-E6C8F2F29A69}" type="datetimeFigureOut">
              <a:rPr lang="en-US" smtClean="0"/>
              <a:t>6/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E58DD9-2B26-3342-8F72-4A3BFDD476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058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1" name="Google Shape;581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582" name="Google Shape;582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449513" y="1143000"/>
            <a:ext cx="19589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8129249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356703"/>
            <a:ext cx="7772400" cy="50134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7563446"/>
            <a:ext cx="6858000" cy="347671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8891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2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766678"/>
            <a:ext cx="1971675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766678"/>
            <a:ext cx="5800725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2698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276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3590057"/>
            <a:ext cx="7886700" cy="599008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9636813"/>
            <a:ext cx="7886700" cy="31500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225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833390"/>
            <a:ext cx="3886200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984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66681"/>
            <a:ext cx="7886700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3530053"/>
            <a:ext cx="3868340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5260078"/>
            <a:ext cx="3868340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3530053"/>
            <a:ext cx="3887391" cy="17300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5260078"/>
            <a:ext cx="3887391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032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1034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931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2073367"/>
            <a:ext cx="4629150" cy="1023348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618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960014"/>
            <a:ext cx="2949178" cy="336005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2073367"/>
            <a:ext cx="4629150" cy="1023348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4320064"/>
            <a:ext cx="2949178" cy="80034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76442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766681"/>
            <a:ext cx="78867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833390"/>
            <a:ext cx="78867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7D088C1-9195-0D47-ABC1-92D9EFBF21F7}" type="datetimeFigureOut">
              <a:rPr lang="en-US" smtClean="0"/>
              <a:t>6/4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3346867"/>
            <a:ext cx="30861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3346867"/>
            <a:ext cx="20574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AA9CCA-DBCB-3348-8A59-987BFC6F94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226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F53F571-7DC5-34D4-91F3-E8529E83374A}"/>
              </a:ext>
            </a:extLst>
          </p:cNvPr>
          <p:cNvGraphicFramePr>
            <a:graphicFrameLocks noGrp="1"/>
          </p:cNvGraphicFramePr>
          <p:nvPr/>
        </p:nvGraphicFramePr>
        <p:xfrm>
          <a:off x="1249379" y="2245399"/>
          <a:ext cx="6595210" cy="538263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662914">
                  <a:extLst>
                    <a:ext uri="{9D8B030D-6E8A-4147-A177-3AD203B41FA5}">
                      <a16:colId xmlns:a16="http://schemas.microsoft.com/office/drawing/2014/main" val="2428620810"/>
                    </a:ext>
                  </a:extLst>
                </a:gridCol>
                <a:gridCol w="2156449">
                  <a:extLst>
                    <a:ext uri="{9D8B030D-6E8A-4147-A177-3AD203B41FA5}">
                      <a16:colId xmlns:a16="http://schemas.microsoft.com/office/drawing/2014/main" val="3487541179"/>
                    </a:ext>
                  </a:extLst>
                </a:gridCol>
                <a:gridCol w="2775847">
                  <a:extLst>
                    <a:ext uri="{9D8B030D-6E8A-4147-A177-3AD203B41FA5}">
                      <a16:colId xmlns:a16="http://schemas.microsoft.com/office/drawing/2014/main" val="3436488931"/>
                    </a:ext>
                  </a:extLst>
                </a:gridCol>
              </a:tblGrid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Nam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ompany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atalog Number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060780184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D3 P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EBioscienc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2-0031-8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671041298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D11b P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D Bioscienc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55739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32015178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NK1.1 AP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7-5941-8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676640265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D68 AF488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3701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426563938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F4/80 BV786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23141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427045924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CR2 BV51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5061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898723351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Ly6C PerCP-Cy5.5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45-5932-8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247400502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D163 APC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55306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951041173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MHCII AF700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56-5321-8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623871621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TNF-α APC-Cy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506343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896430551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D38 PE-Cy5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Abcam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ab25043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979242384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D11c AF64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1731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87058950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CL5 PE-Cy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iolegend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149105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3159108710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CR5 BV605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BD Bioscience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74369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404253428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Ly6G PE-Cy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25-9668-8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1665254633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XCR3 PE-Cy7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Invitrogen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25-1831-82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349666840"/>
                  </a:ext>
                </a:extLst>
              </a:tr>
              <a:tr h="299035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>
                          <a:effectLst/>
                        </a:rPr>
                        <a:t>CD8b</a:t>
                      </a:r>
                      <a:endParaRPr lang="en-CA" sz="12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 dirty="0">
                          <a:effectLst/>
                        </a:rPr>
                        <a:t>BD Bioscience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</a:pPr>
                      <a:r>
                        <a:rPr lang="en-CA" sz="1100" dirty="0">
                          <a:effectLst/>
                        </a:rPr>
                        <a:t>567737</a:t>
                      </a:r>
                      <a:endParaRPr lang="en-CA" sz="12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68580" marR="68580" marT="9525" marB="0" anchor="ctr"/>
                </a:tc>
                <a:extLst>
                  <a:ext uri="{0D108BD9-81ED-4DB2-BD59-A6C34878D82A}">
                    <a16:rowId xmlns:a16="http://schemas.microsoft.com/office/drawing/2014/main" val="2642893825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CE8BE1F-46AF-EAAC-1B43-98230987D739}"/>
              </a:ext>
            </a:extLst>
          </p:cNvPr>
          <p:cNvSpPr txBox="1"/>
          <p:nvPr/>
        </p:nvSpPr>
        <p:spPr>
          <a:xfrm>
            <a:off x="1249379" y="1439542"/>
            <a:ext cx="6545178" cy="4563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CA" sz="14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Table 2. Flow cytometry antibodies.</a:t>
            </a:r>
            <a:endParaRPr lang="en-CA" sz="14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7495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82</Words>
  <Application>Microsoft Macintosh PowerPoint</Application>
  <PresentationFormat>Custom</PresentationFormat>
  <Paragraphs>5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smine Benslimane (CUSM)</dc:creator>
  <cp:lastModifiedBy>Yasmine Benslimane (CUSM)</cp:lastModifiedBy>
  <cp:revision>11</cp:revision>
  <dcterms:created xsi:type="dcterms:W3CDTF">2024-06-04T23:51:01Z</dcterms:created>
  <dcterms:modified xsi:type="dcterms:W3CDTF">2024-06-05T01:37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a7d8d5d-78e2-4a62-9fcd-016eb5e4c57c_Enabled">
    <vt:lpwstr>true</vt:lpwstr>
  </property>
  <property fmtid="{D5CDD505-2E9C-101B-9397-08002B2CF9AE}" pid="3" name="MSIP_Label_6a7d8d5d-78e2-4a62-9fcd-016eb5e4c57c_SetDate">
    <vt:lpwstr>2024-06-04T23:52:34Z</vt:lpwstr>
  </property>
  <property fmtid="{D5CDD505-2E9C-101B-9397-08002B2CF9AE}" pid="4" name="MSIP_Label_6a7d8d5d-78e2-4a62-9fcd-016eb5e4c57c_Method">
    <vt:lpwstr>Standard</vt:lpwstr>
  </property>
  <property fmtid="{D5CDD505-2E9C-101B-9397-08002B2CF9AE}" pid="5" name="MSIP_Label_6a7d8d5d-78e2-4a62-9fcd-016eb5e4c57c_Name">
    <vt:lpwstr>Général</vt:lpwstr>
  </property>
  <property fmtid="{D5CDD505-2E9C-101B-9397-08002B2CF9AE}" pid="6" name="MSIP_Label_6a7d8d5d-78e2-4a62-9fcd-016eb5e4c57c_SiteId">
    <vt:lpwstr>06e1fe28-5f8b-4075-bf6c-ae24be1a7992</vt:lpwstr>
  </property>
  <property fmtid="{D5CDD505-2E9C-101B-9397-08002B2CF9AE}" pid="7" name="MSIP_Label_6a7d8d5d-78e2-4a62-9fcd-016eb5e4c57c_ActionId">
    <vt:lpwstr>7787e28e-b149-4962-94cc-d172c1dcb2b1</vt:lpwstr>
  </property>
  <property fmtid="{D5CDD505-2E9C-101B-9397-08002B2CF9AE}" pid="8" name="MSIP_Label_6a7d8d5d-78e2-4a62-9fcd-016eb5e4c57c_ContentBits">
    <vt:lpwstr>0</vt:lpwstr>
  </property>
</Properties>
</file>